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9" r:id="rId3"/>
    <p:sldId id="268" r:id="rId4"/>
    <p:sldId id="267" r:id="rId5"/>
    <p:sldId id="266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25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ori%20Park\Dropbox\Berberis%203%20species%20MS\G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ori%20Park\Dropbox\Berberis%203%20species%20MS\G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207077304725349E-2"/>
          <c:y val="0.12095172874570127"/>
          <c:w val="0.84134869229842746"/>
          <c:h val="0.414877399266806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Up!$K$2</c:f>
              <c:strCache>
                <c:ptCount val="1"/>
                <c:pt idx="0">
                  <c:v>B. thunberg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Up!$J$3:$J$34</c:f>
              <c:strCache>
                <c:ptCount val="32"/>
                <c:pt idx="0">
                  <c:v>sucrose metabolic process</c:v>
                </c:pt>
                <c:pt idx="1">
                  <c:v>starch metabolic process</c:v>
                </c:pt>
                <c:pt idx="2">
                  <c:v>regulation of transcription, DNA-templated</c:v>
                </c:pt>
                <c:pt idx="3">
                  <c:v>serine family amino acid metabolic process</c:v>
                </c:pt>
                <c:pt idx="4">
                  <c:v>response to jasmonic acid</c:v>
                </c:pt>
                <c:pt idx="5">
                  <c:v>cellular process</c:v>
                </c:pt>
                <c:pt idx="6">
                  <c:v>ion transmembrane transport</c:v>
                </c:pt>
                <c:pt idx="7">
                  <c:v>plasma membrane</c:v>
                </c:pt>
                <c:pt idx="8">
                  <c:v>integral component of membrane</c:v>
                </c:pt>
                <c:pt idx="9">
                  <c:v>nucleus</c:v>
                </c:pt>
                <c:pt idx="10">
                  <c:v>membrane</c:v>
                </c:pt>
                <c:pt idx="11">
                  <c:v>cytoplasm</c:v>
                </c:pt>
                <c:pt idx="12">
                  <c:v>cytosol</c:v>
                </c:pt>
                <c:pt idx="13">
                  <c:v>extracellular region</c:v>
                </c:pt>
                <c:pt idx="14">
                  <c:v>chloroplast</c:v>
                </c:pt>
                <c:pt idx="15">
                  <c:v>plasmodesma</c:v>
                </c:pt>
                <c:pt idx="16">
                  <c:v>cellular anatomical entity</c:v>
                </c:pt>
                <c:pt idx="17">
                  <c:v>cell wall</c:v>
                </c:pt>
                <c:pt idx="18">
                  <c:v>Golgi apparatus</c:v>
                </c:pt>
                <c:pt idx="19">
                  <c:v>transcription regulator complex</c:v>
                </c:pt>
                <c:pt idx="20">
                  <c:v>endoplasmic reticulum</c:v>
                </c:pt>
                <c:pt idx="21">
                  <c:v>vacuole</c:v>
                </c:pt>
                <c:pt idx="22">
                  <c:v>protein binding</c:v>
                </c:pt>
                <c:pt idx="23">
                  <c:v>metal ion binding</c:v>
                </c:pt>
                <c:pt idx="24">
                  <c:v>ATP binding</c:v>
                </c:pt>
                <c:pt idx="25">
                  <c:v>hydrolase activity</c:v>
                </c:pt>
                <c:pt idx="26">
                  <c:v>oxidoreductase activity</c:v>
                </c:pt>
                <c:pt idx="27">
                  <c:v>binding</c:v>
                </c:pt>
                <c:pt idx="28">
                  <c:v>nucleotide binding</c:v>
                </c:pt>
                <c:pt idx="29">
                  <c:v>transferase activity</c:v>
                </c:pt>
                <c:pt idx="30">
                  <c:v>DNA-binding transcription factor activity</c:v>
                </c:pt>
                <c:pt idx="31">
                  <c:v>heme binding</c:v>
                </c:pt>
              </c:strCache>
            </c:strRef>
          </c:cat>
          <c:val>
            <c:numRef>
              <c:f>Up!$K$3:$K$34</c:f>
              <c:numCache>
                <c:formatCode>General</c:formatCode>
                <c:ptCount val="32"/>
                <c:pt idx="0">
                  <c:v>21</c:v>
                </c:pt>
                <c:pt idx="1">
                  <c:v>20</c:v>
                </c:pt>
                <c:pt idx="2">
                  <c:v>18</c:v>
                </c:pt>
                <c:pt idx="3">
                  <c:v>13</c:v>
                </c:pt>
                <c:pt idx="4">
                  <c:v>11</c:v>
                </c:pt>
                <c:pt idx="5">
                  <c:v>9</c:v>
                </c:pt>
                <c:pt idx="6">
                  <c:v>8</c:v>
                </c:pt>
                <c:pt idx="7">
                  <c:v>65</c:v>
                </c:pt>
                <c:pt idx="8">
                  <c:v>55</c:v>
                </c:pt>
                <c:pt idx="9">
                  <c:v>34</c:v>
                </c:pt>
                <c:pt idx="10">
                  <c:v>30</c:v>
                </c:pt>
                <c:pt idx="11">
                  <c:v>23</c:v>
                </c:pt>
                <c:pt idx="12">
                  <c:v>23</c:v>
                </c:pt>
                <c:pt idx="13">
                  <c:v>21</c:v>
                </c:pt>
                <c:pt idx="14">
                  <c:v>19</c:v>
                </c:pt>
                <c:pt idx="15">
                  <c:v>18</c:v>
                </c:pt>
                <c:pt idx="16">
                  <c:v>16</c:v>
                </c:pt>
                <c:pt idx="17">
                  <c:v>11</c:v>
                </c:pt>
                <c:pt idx="18">
                  <c:v>11</c:v>
                </c:pt>
                <c:pt idx="19">
                  <c:v>11</c:v>
                </c:pt>
                <c:pt idx="20">
                  <c:v>10</c:v>
                </c:pt>
                <c:pt idx="21">
                  <c:v>10</c:v>
                </c:pt>
                <c:pt idx="22">
                  <c:v>54</c:v>
                </c:pt>
                <c:pt idx="23">
                  <c:v>35</c:v>
                </c:pt>
                <c:pt idx="24">
                  <c:v>33</c:v>
                </c:pt>
                <c:pt idx="25">
                  <c:v>27</c:v>
                </c:pt>
                <c:pt idx="26">
                  <c:v>25</c:v>
                </c:pt>
                <c:pt idx="27">
                  <c:v>24</c:v>
                </c:pt>
                <c:pt idx="28">
                  <c:v>15</c:v>
                </c:pt>
                <c:pt idx="29">
                  <c:v>14</c:v>
                </c:pt>
                <c:pt idx="30">
                  <c:v>11</c:v>
                </c:pt>
                <c:pt idx="3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37-4AB0-9AA5-9B41EAD5BF85}"/>
            </c:ext>
          </c:extLst>
        </c:ser>
        <c:ser>
          <c:idx val="1"/>
          <c:order val="1"/>
          <c:tx>
            <c:strRef>
              <c:f>Up!$L$2</c:f>
              <c:strCache>
                <c:ptCount val="1"/>
                <c:pt idx="0">
                  <c:v>B. amurensi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Up!$J$3:$J$34</c:f>
              <c:strCache>
                <c:ptCount val="32"/>
                <c:pt idx="0">
                  <c:v>sucrose metabolic process</c:v>
                </c:pt>
                <c:pt idx="1">
                  <c:v>starch metabolic process</c:v>
                </c:pt>
                <c:pt idx="2">
                  <c:v>regulation of transcription, DNA-templated</c:v>
                </c:pt>
                <c:pt idx="3">
                  <c:v>serine family amino acid metabolic process</c:v>
                </c:pt>
                <c:pt idx="4">
                  <c:v>response to jasmonic acid</c:v>
                </c:pt>
                <c:pt idx="5">
                  <c:v>cellular process</c:v>
                </c:pt>
                <c:pt idx="6">
                  <c:v>ion transmembrane transport</c:v>
                </c:pt>
                <c:pt idx="7">
                  <c:v>plasma membrane</c:v>
                </c:pt>
                <c:pt idx="8">
                  <c:v>integral component of membrane</c:v>
                </c:pt>
                <c:pt idx="9">
                  <c:v>nucleus</c:v>
                </c:pt>
                <c:pt idx="10">
                  <c:v>membrane</c:v>
                </c:pt>
                <c:pt idx="11">
                  <c:v>cytoplasm</c:v>
                </c:pt>
                <c:pt idx="12">
                  <c:v>cytosol</c:v>
                </c:pt>
                <c:pt idx="13">
                  <c:v>extracellular region</c:v>
                </c:pt>
                <c:pt idx="14">
                  <c:v>chloroplast</c:v>
                </c:pt>
                <c:pt idx="15">
                  <c:v>plasmodesma</c:v>
                </c:pt>
                <c:pt idx="16">
                  <c:v>cellular anatomical entity</c:v>
                </c:pt>
                <c:pt idx="17">
                  <c:v>cell wall</c:v>
                </c:pt>
                <c:pt idx="18">
                  <c:v>Golgi apparatus</c:v>
                </c:pt>
                <c:pt idx="19">
                  <c:v>transcription regulator complex</c:v>
                </c:pt>
                <c:pt idx="20">
                  <c:v>endoplasmic reticulum</c:v>
                </c:pt>
                <c:pt idx="21">
                  <c:v>vacuole</c:v>
                </c:pt>
                <c:pt idx="22">
                  <c:v>protein binding</c:v>
                </c:pt>
                <c:pt idx="23">
                  <c:v>metal ion binding</c:v>
                </c:pt>
                <c:pt idx="24">
                  <c:v>ATP binding</c:v>
                </c:pt>
                <c:pt idx="25">
                  <c:v>hydrolase activity</c:v>
                </c:pt>
                <c:pt idx="26">
                  <c:v>oxidoreductase activity</c:v>
                </c:pt>
                <c:pt idx="27">
                  <c:v>binding</c:v>
                </c:pt>
                <c:pt idx="28">
                  <c:v>nucleotide binding</c:v>
                </c:pt>
                <c:pt idx="29">
                  <c:v>transferase activity</c:v>
                </c:pt>
                <c:pt idx="30">
                  <c:v>DNA-binding transcription factor activity</c:v>
                </c:pt>
                <c:pt idx="31">
                  <c:v>heme binding</c:v>
                </c:pt>
              </c:strCache>
            </c:strRef>
          </c:cat>
          <c:val>
            <c:numRef>
              <c:f>Up!$L$3:$L$34</c:f>
              <c:numCache>
                <c:formatCode>General</c:formatCode>
                <c:ptCount val="32"/>
                <c:pt idx="0">
                  <c:v>8</c:v>
                </c:pt>
                <c:pt idx="1">
                  <c:v>7</c:v>
                </c:pt>
                <c:pt idx="2">
                  <c:v>11</c:v>
                </c:pt>
                <c:pt idx="3">
                  <c:v>11</c:v>
                </c:pt>
                <c:pt idx="4">
                  <c:v>5</c:v>
                </c:pt>
                <c:pt idx="5">
                  <c:v>6</c:v>
                </c:pt>
                <c:pt idx="6">
                  <c:v>5</c:v>
                </c:pt>
                <c:pt idx="7">
                  <c:v>49</c:v>
                </c:pt>
                <c:pt idx="8">
                  <c:v>30</c:v>
                </c:pt>
                <c:pt idx="9">
                  <c:v>27</c:v>
                </c:pt>
                <c:pt idx="10">
                  <c:v>33</c:v>
                </c:pt>
                <c:pt idx="11">
                  <c:v>17</c:v>
                </c:pt>
                <c:pt idx="12">
                  <c:v>18</c:v>
                </c:pt>
                <c:pt idx="13">
                  <c:v>10</c:v>
                </c:pt>
                <c:pt idx="14">
                  <c:v>7</c:v>
                </c:pt>
                <c:pt idx="15">
                  <c:v>8</c:v>
                </c:pt>
                <c:pt idx="16">
                  <c:v>5</c:v>
                </c:pt>
                <c:pt idx="17">
                  <c:v>7</c:v>
                </c:pt>
                <c:pt idx="18">
                  <c:v>6</c:v>
                </c:pt>
                <c:pt idx="19">
                  <c:v>7</c:v>
                </c:pt>
                <c:pt idx="20">
                  <c:v>5</c:v>
                </c:pt>
                <c:pt idx="21">
                  <c:v>6</c:v>
                </c:pt>
                <c:pt idx="22">
                  <c:v>31</c:v>
                </c:pt>
                <c:pt idx="23">
                  <c:v>19</c:v>
                </c:pt>
                <c:pt idx="24">
                  <c:v>17</c:v>
                </c:pt>
                <c:pt idx="25">
                  <c:v>7</c:v>
                </c:pt>
                <c:pt idx="26">
                  <c:v>10</c:v>
                </c:pt>
                <c:pt idx="27">
                  <c:v>13</c:v>
                </c:pt>
                <c:pt idx="28">
                  <c:v>5</c:v>
                </c:pt>
                <c:pt idx="29">
                  <c:v>7</c:v>
                </c:pt>
                <c:pt idx="30">
                  <c:v>7</c:v>
                </c:pt>
                <c:pt idx="3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37-4AB0-9AA5-9B41EAD5BF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748023040"/>
        <c:axId val="748024704"/>
      </c:barChart>
      <c:catAx>
        <c:axId val="748023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8024704"/>
        <c:crosses val="autoZero"/>
        <c:auto val="1"/>
        <c:lblAlgn val="ctr"/>
        <c:lblOffset val="100"/>
        <c:noMultiLvlLbl val="0"/>
      </c:catAx>
      <c:valAx>
        <c:axId val="748024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8023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119021384007864"/>
          <c:y val="0.12879618310163307"/>
          <c:w val="0.15564186632180202"/>
          <c:h val="0.113541274311098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1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20800702024819"/>
          <c:y val="5.8718036099701651E-2"/>
          <c:w val="0.8594015482889753"/>
          <c:h val="0.441512624133828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own!$C$1</c:f>
              <c:strCache>
                <c:ptCount val="1"/>
                <c:pt idx="0">
                  <c:v>B thunbergi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Down!$B$2:$B$39</c:f>
              <c:strCache>
                <c:ptCount val="38"/>
                <c:pt idx="0">
                  <c:v>regulation of transcription, DNA-templated</c:v>
                </c:pt>
                <c:pt idx="1">
                  <c:v>serine family amino acid metabolic process</c:v>
                </c:pt>
                <c:pt idx="2">
                  <c:v>starch metabolic process</c:v>
                </c:pt>
                <c:pt idx="3">
                  <c:v>sucrose metabolic process</c:v>
                </c:pt>
                <c:pt idx="4">
                  <c:v>cellular process</c:v>
                </c:pt>
                <c:pt idx="5">
                  <c:v>obsolete acyl-carrier-protein biosynthetic process</c:v>
                </c:pt>
                <c:pt idx="6">
                  <c:v>protein phosphorylation</c:v>
                </c:pt>
                <c:pt idx="7">
                  <c:v>response to salt stress</c:v>
                </c:pt>
                <c:pt idx="8">
                  <c:v>response to water deprivation</c:v>
                </c:pt>
                <c:pt idx="9">
                  <c:v>phosphorylation</c:v>
                </c:pt>
                <c:pt idx="10">
                  <c:v>cell division</c:v>
                </c:pt>
                <c:pt idx="11">
                  <c:v>protein ubiquitination</c:v>
                </c:pt>
                <c:pt idx="12">
                  <c:v>plasma membrane</c:v>
                </c:pt>
                <c:pt idx="13">
                  <c:v>nucleus</c:v>
                </c:pt>
                <c:pt idx="14">
                  <c:v>integral component of membrane</c:v>
                </c:pt>
                <c:pt idx="15">
                  <c:v>cytosol</c:v>
                </c:pt>
                <c:pt idx="16">
                  <c:v>membrane</c:v>
                </c:pt>
                <c:pt idx="17">
                  <c:v>cytoplasm</c:v>
                </c:pt>
                <c:pt idx="18">
                  <c:v>plasmodesma</c:v>
                </c:pt>
                <c:pt idx="19">
                  <c:v>chloroplast</c:v>
                </c:pt>
                <c:pt idx="20">
                  <c:v>extracellular region</c:v>
                </c:pt>
                <c:pt idx="21">
                  <c:v>transcription regulator complex</c:v>
                </c:pt>
                <c:pt idx="22">
                  <c:v>Golgi apparatus</c:v>
                </c:pt>
                <c:pt idx="23">
                  <c:v>endoplasmic reticulum</c:v>
                </c:pt>
                <c:pt idx="24">
                  <c:v>plant-type cell wall</c:v>
                </c:pt>
                <c:pt idx="25">
                  <c:v>protein binding</c:v>
                </c:pt>
                <c:pt idx="26">
                  <c:v>ATP binding</c:v>
                </c:pt>
                <c:pt idx="27">
                  <c:v>metal ion binding</c:v>
                </c:pt>
                <c:pt idx="28">
                  <c:v>DNA binding</c:v>
                </c:pt>
                <c:pt idx="29">
                  <c:v>nucleotide binding</c:v>
                </c:pt>
                <c:pt idx="30">
                  <c:v>binding</c:v>
                </c:pt>
                <c:pt idx="31">
                  <c:v>hydrolase activity</c:v>
                </c:pt>
                <c:pt idx="32">
                  <c:v>DNA-binding transcription factor activity</c:v>
                </c:pt>
                <c:pt idx="33">
                  <c:v>transferase activity</c:v>
                </c:pt>
                <c:pt idx="34">
                  <c:v>protein serine/threonine kinase activity</c:v>
                </c:pt>
                <c:pt idx="35">
                  <c:v>protein kinase activity</c:v>
                </c:pt>
                <c:pt idx="36">
                  <c:v>sequence-specific DNA binding</c:v>
                </c:pt>
                <c:pt idx="37">
                  <c:v>oxidoreductase activity</c:v>
                </c:pt>
              </c:strCache>
            </c:strRef>
          </c:cat>
          <c:val>
            <c:numRef>
              <c:f>Down!$C$2:$C$39</c:f>
              <c:numCache>
                <c:formatCode>General</c:formatCode>
                <c:ptCount val="38"/>
                <c:pt idx="0">
                  <c:v>110</c:v>
                </c:pt>
                <c:pt idx="1">
                  <c:v>58</c:v>
                </c:pt>
                <c:pt idx="2">
                  <c:v>52</c:v>
                </c:pt>
                <c:pt idx="3">
                  <c:v>48</c:v>
                </c:pt>
                <c:pt idx="4">
                  <c:v>43</c:v>
                </c:pt>
                <c:pt idx="5">
                  <c:v>41</c:v>
                </c:pt>
                <c:pt idx="6">
                  <c:v>41</c:v>
                </c:pt>
                <c:pt idx="7">
                  <c:v>38</c:v>
                </c:pt>
                <c:pt idx="8">
                  <c:v>35</c:v>
                </c:pt>
                <c:pt idx="9">
                  <c:v>31</c:v>
                </c:pt>
                <c:pt idx="10">
                  <c:v>28</c:v>
                </c:pt>
                <c:pt idx="11">
                  <c:v>27</c:v>
                </c:pt>
                <c:pt idx="12">
                  <c:v>257</c:v>
                </c:pt>
                <c:pt idx="13">
                  <c:v>233</c:v>
                </c:pt>
                <c:pt idx="14">
                  <c:v>188</c:v>
                </c:pt>
                <c:pt idx="15">
                  <c:v>130</c:v>
                </c:pt>
                <c:pt idx="16">
                  <c:v>126</c:v>
                </c:pt>
                <c:pt idx="17">
                  <c:v>125</c:v>
                </c:pt>
                <c:pt idx="18">
                  <c:v>97</c:v>
                </c:pt>
                <c:pt idx="19">
                  <c:v>80</c:v>
                </c:pt>
                <c:pt idx="20">
                  <c:v>74</c:v>
                </c:pt>
                <c:pt idx="21">
                  <c:v>65</c:v>
                </c:pt>
                <c:pt idx="22">
                  <c:v>58</c:v>
                </c:pt>
                <c:pt idx="23">
                  <c:v>55</c:v>
                </c:pt>
                <c:pt idx="24">
                  <c:v>52</c:v>
                </c:pt>
                <c:pt idx="25">
                  <c:v>259</c:v>
                </c:pt>
                <c:pt idx="26">
                  <c:v>146</c:v>
                </c:pt>
                <c:pt idx="27">
                  <c:v>82</c:v>
                </c:pt>
                <c:pt idx="28">
                  <c:v>81</c:v>
                </c:pt>
                <c:pt idx="29">
                  <c:v>67</c:v>
                </c:pt>
                <c:pt idx="30">
                  <c:v>66</c:v>
                </c:pt>
                <c:pt idx="31">
                  <c:v>63</c:v>
                </c:pt>
                <c:pt idx="32">
                  <c:v>58</c:v>
                </c:pt>
                <c:pt idx="33">
                  <c:v>49</c:v>
                </c:pt>
                <c:pt idx="34">
                  <c:v>37</c:v>
                </c:pt>
                <c:pt idx="35">
                  <c:v>33</c:v>
                </c:pt>
                <c:pt idx="36">
                  <c:v>29</c:v>
                </c:pt>
                <c:pt idx="37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71-4375-8A92-8BC437CB4FC2}"/>
            </c:ext>
          </c:extLst>
        </c:ser>
        <c:ser>
          <c:idx val="1"/>
          <c:order val="1"/>
          <c:tx>
            <c:strRef>
              <c:f>Down!$D$1</c:f>
              <c:strCache>
                <c:ptCount val="1"/>
                <c:pt idx="0">
                  <c:v>B amurensi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Down!$B$2:$B$39</c:f>
              <c:strCache>
                <c:ptCount val="38"/>
                <c:pt idx="0">
                  <c:v>regulation of transcription, DNA-templated</c:v>
                </c:pt>
                <c:pt idx="1">
                  <c:v>serine family amino acid metabolic process</c:v>
                </c:pt>
                <c:pt idx="2">
                  <c:v>starch metabolic process</c:v>
                </c:pt>
                <c:pt idx="3">
                  <c:v>sucrose metabolic process</c:v>
                </c:pt>
                <c:pt idx="4">
                  <c:v>cellular process</c:v>
                </c:pt>
                <c:pt idx="5">
                  <c:v>obsolete acyl-carrier-protein biosynthetic process</c:v>
                </c:pt>
                <c:pt idx="6">
                  <c:v>protein phosphorylation</c:v>
                </c:pt>
                <c:pt idx="7">
                  <c:v>response to salt stress</c:v>
                </c:pt>
                <c:pt idx="8">
                  <c:v>response to water deprivation</c:v>
                </c:pt>
                <c:pt idx="9">
                  <c:v>phosphorylation</c:v>
                </c:pt>
                <c:pt idx="10">
                  <c:v>cell division</c:v>
                </c:pt>
                <c:pt idx="11">
                  <c:v>protein ubiquitination</c:v>
                </c:pt>
                <c:pt idx="12">
                  <c:v>plasma membrane</c:v>
                </c:pt>
                <c:pt idx="13">
                  <c:v>nucleus</c:v>
                </c:pt>
                <c:pt idx="14">
                  <c:v>integral component of membrane</c:v>
                </c:pt>
                <c:pt idx="15">
                  <c:v>cytosol</c:v>
                </c:pt>
                <c:pt idx="16">
                  <c:v>membrane</c:v>
                </c:pt>
                <c:pt idx="17">
                  <c:v>cytoplasm</c:v>
                </c:pt>
                <c:pt idx="18">
                  <c:v>plasmodesma</c:v>
                </c:pt>
                <c:pt idx="19">
                  <c:v>chloroplast</c:v>
                </c:pt>
                <c:pt idx="20">
                  <c:v>extracellular region</c:v>
                </c:pt>
                <c:pt idx="21">
                  <c:v>transcription regulator complex</c:v>
                </c:pt>
                <c:pt idx="22">
                  <c:v>Golgi apparatus</c:v>
                </c:pt>
                <c:pt idx="23">
                  <c:v>endoplasmic reticulum</c:v>
                </c:pt>
                <c:pt idx="24">
                  <c:v>plant-type cell wall</c:v>
                </c:pt>
                <c:pt idx="25">
                  <c:v>protein binding</c:v>
                </c:pt>
                <c:pt idx="26">
                  <c:v>ATP binding</c:v>
                </c:pt>
                <c:pt idx="27">
                  <c:v>metal ion binding</c:v>
                </c:pt>
                <c:pt idx="28">
                  <c:v>DNA binding</c:v>
                </c:pt>
                <c:pt idx="29">
                  <c:v>nucleotide binding</c:v>
                </c:pt>
                <c:pt idx="30">
                  <c:v>binding</c:v>
                </c:pt>
                <c:pt idx="31">
                  <c:v>hydrolase activity</c:v>
                </c:pt>
                <c:pt idx="32">
                  <c:v>DNA-binding transcription factor activity</c:v>
                </c:pt>
                <c:pt idx="33">
                  <c:v>transferase activity</c:v>
                </c:pt>
                <c:pt idx="34">
                  <c:v>protein serine/threonine kinase activity</c:v>
                </c:pt>
                <c:pt idx="35">
                  <c:v>protein kinase activity</c:v>
                </c:pt>
                <c:pt idx="36">
                  <c:v>sequence-specific DNA binding</c:v>
                </c:pt>
                <c:pt idx="37">
                  <c:v>oxidoreductase activity</c:v>
                </c:pt>
              </c:strCache>
            </c:strRef>
          </c:cat>
          <c:val>
            <c:numRef>
              <c:f>Down!$D$2:$D$39</c:f>
              <c:numCache>
                <c:formatCode>General</c:formatCode>
                <c:ptCount val="38"/>
                <c:pt idx="0">
                  <c:v>71</c:v>
                </c:pt>
                <c:pt idx="1">
                  <c:v>37</c:v>
                </c:pt>
                <c:pt idx="2">
                  <c:v>27</c:v>
                </c:pt>
                <c:pt idx="3">
                  <c:v>25</c:v>
                </c:pt>
                <c:pt idx="4">
                  <c:v>32</c:v>
                </c:pt>
                <c:pt idx="5">
                  <c:v>23</c:v>
                </c:pt>
                <c:pt idx="6">
                  <c:v>24</c:v>
                </c:pt>
                <c:pt idx="7">
                  <c:v>22</c:v>
                </c:pt>
                <c:pt idx="8">
                  <c:v>17</c:v>
                </c:pt>
                <c:pt idx="9">
                  <c:v>18</c:v>
                </c:pt>
                <c:pt idx="10">
                  <c:v>16</c:v>
                </c:pt>
                <c:pt idx="11">
                  <c:v>19</c:v>
                </c:pt>
                <c:pt idx="12">
                  <c:v>149</c:v>
                </c:pt>
                <c:pt idx="13">
                  <c:v>152</c:v>
                </c:pt>
                <c:pt idx="14">
                  <c:v>108</c:v>
                </c:pt>
                <c:pt idx="15">
                  <c:v>72</c:v>
                </c:pt>
                <c:pt idx="16">
                  <c:v>95</c:v>
                </c:pt>
                <c:pt idx="17">
                  <c:v>89</c:v>
                </c:pt>
                <c:pt idx="18">
                  <c:v>51</c:v>
                </c:pt>
                <c:pt idx="19">
                  <c:v>41</c:v>
                </c:pt>
                <c:pt idx="20">
                  <c:v>36</c:v>
                </c:pt>
                <c:pt idx="21">
                  <c:v>44</c:v>
                </c:pt>
                <c:pt idx="22">
                  <c:v>35</c:v>
                </c:pt>
                <c:pt idx="23">
                  <c:v>33</c:v>
                </c:pt>
                <c:pt idx="24">
                  <c:v>30</c:v>
                </c:pt>
                <c:pt idx="25">
                  <c:v>167</c:v>
                </c:pt>
                <c:pt idx="26">
                  <c:v>90</c:v>
                </c:pt>
                <c:pt idx="27">
                  <c:v>53</c:v>
                </c:pt>
                <c:pt idx="28">
                  <c:v>48</c:v>
                </c:pt>
                <c:pt idx="29">
                  <c:v>48</c:v>
                </c:pt>
                <c:pt idx="30">
                  <c:v>44</c:v>
                </c:pt>
                <c:pt idx="31">
                  <c:v>51</c:v>
                </c:pt>
                <c:pt idx="32">
                  <c:v>36</c:v>
                </c:pt>
                <c:pt idx="33">
                  <c:v>37</c:v>
                </c:pt>
                <c:pt idx="34">
                  <c:v>29</c:v>
                </c:pt>
                <c:pt idx="35">
                  <c:v>19</c:v>
                </c:pt>
                <c:pt idx="36">
                  <c:v>25</c:v>
                </c:pt>
                <c:pt idx="37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71-4375-8A92-8BC437CB4F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"/>
        <c:axId val="674638015"/>
        <c:axId val="674640095"/>
      </c:barChart>
      <c:catAx>
        <c:axId val="674638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4640095"/>
        <c:crosses val="autoZero"/>
        <c:auto val="1"/>
        <c:lblAlgn val="ctr"/>
        <c:lblOffset val="100"/>
        <c:noMultiLvlLbl val="0"/>
      </c:catAx>
      <c:valAx>
        <c:axId val="6746400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 of uni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46380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625672937459679"/>
          <c:y val="0.15063799257439064"/>
          <c:w val="0.1868539547762714"/>
          <c:h val="9.44119001070196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1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E1A14E2-19FD-4E95-B481-8E02EB3805E9}" type="doc">
      <dgm:prSet loTypeId="urn:microsoft.com/office/officeart/2005/8/layout/venn1" loCatId="relationship" qsTypeId="urn:microsoft.com/office/officeart/2005/8/quickstyle/simple1" qsCatId="simple" csTypeId="urn:microsoft.com/office/officeart/2005/8/colors/colorful4" csCatId="colorful" phldr="1"/>
      <dgm:spPr/>
    </dgm:pt>
    <dgm:pt modelId="{57370633-D8C0-4378-8908-A7448631B801}">
      <dgm:prSet phldrT="[Text]" custT="1"/>
      <dgm:spPr>
        <a:solidFill>
          <a:srgbClr val="E325E8">
            <a:alpha val="50000"/>
          </a:srgbClr>
        </a:solidFill>
      </dgm:spPr>
      <dgm:t>
        <a:bodyPr/>
        <a:lstStyle/>
        <a:p>
          <a:endParaRPr lang="en-US" sz="20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E3C3A12-CFBA-42D1-B4D8-09E9718C85BA}" type="parTrans" cxnId="{CF4AF3C1-3F03-4957-8F5C-2AD9F093CDD0}">
      <dgm:prSet/>
      <dgm:spPr/>
      <dgm:t>
        <a:bodyPr/>
        <a:lstStyle/>
        <a:p>
          <a:endParaRPr lang="en-US"/>
        </a:p>
      </dgm:t>
    </dgm:pt>
    <dgm:pt modelId="{3F083593-D0DD-4F12-BD32-6C0793E6AE1E}" type="sibTrans" cxnId="{CF4AF3C1-3F03-4957-8F5C-2AD9F093CDD0}">
      <dgm:prSet/>
      <dgm:spPr/>
      <dgm:t>
        <a:bodyPr/>
        <a:lstStyle/>
        <a:p>
          <a:endParaRPr lang="en-US"/>
        </a:p>
      </dgm:t>
    </dgm:pt>
    <dgm:pt modelId="{A94CC6B6-0902-4F08-BDA3-FFA46E655C21}">
      <dgm:prSet phldrT="[Text]" custT="1"/>
      <dgm:spPr/>
      <dgm:t>
        <a:bodyPr/>
        <a:lstStyle/>
        <a:p>
          <a:endParaRPr lang="en-US" sz="2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F0296AA-8FEB-4911-B042-86714345132F}" type="parTrans" cxnId="{ABC3F7E9-A992-4404-A8B4-1AED97D2AB9B}">
      <dgm:prSet/>
      <dgm:spPr/>
      <dgm:t>
        <a:bodyPr/>
        <a:lstStyle/>
        <a:p>
          <a:endParaRPr lang="en-US"/>
        </a:p>
      </dgm:t>
    </dgm:pt>
    <dgm:pt modelId="{54553347-1A16-446E-94E6-9C874E9EEE69}" type="sibTrans" cxnId="{ABC3F7E9-A992-4404-A8B4-1AED97D2AB9B}">
      <dgm:prSet/>
      <dgm:spPr/>
      <dgm:t>
        <a:bodyPr/>
        <a:lstStyle/>
        <a:p>
          <a:endParaRPr lang="en-US"/>
        </a:p>
      </dgm:t>
    </dgm:pt>
    <dgm:pt modelId="{23C6CA5F-52DB-4FE0-ACC5-0DC1BF0811F3}">
      <dgm:prSet phldrT="[Text]" custT="1"/>
      <dgm:spPr>
        <a:solidFill>
          <a:srgbClr val="FFFF00">
            <a:alpha val="50000"/>
          </a:srgbClr>
        </a:solidFill>
      </dgm:spPr>
      <dgm:t>
        <a:bodyPr/>
        <a:lstStyle/>
        <a:p>
          <a:endParaRPr lang="en-US" sz="54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AE87402-5C21-4F40-85E5-E4A2860BF368}" type="parTrans" cxnId="{CA2E6C2C-40BD-423D-8F21-296B07A8048E}">
      <dgm:prSet/>
      <dgm:spPr/>
      <dgm:t>
        <a:bodyPr/>
        <a:lstStyle/>
        <a:p>
          <a:endParaRPr lang="en-US"/>
        </a:p>
      </dgm:t>
    </dgm:pt>
    <dgm:pt modelId="{838F3D91-E2F8-467B-9453-1B8E0ACC7AFE}" type="sibTrans" cxnId="{CA2E6C2C-40BD-423D-8F21-296B07A8048E}">
      <dgm:prSet/>
      <dgm:spPr/>
      <dgm:t>
        <a:bodyPr/>
        <a:lstStyle/>
        <a:p>
          <a:endParaRPr lang="en-US"/>
        </a:p>
      </dgm:t>
    </dgm:pt>
    <dgm:pt modelId="{9FBCDCD4-7E21-4714-8908-19321FF1462C}" type="pres">
      <dgm:prSet presAssocID="{4E1A14E2-19FD-4E95-B481-8E02EB3805E9}" presName="compositeShape" presStyleCnt="0">
        <dgm:presLayoutVars>
          <dgm:chMax val="7"/>
          <dgm:dir/>
          <dgm:resizeHandles val="exact"/>
        </dgm:presLayoutVars>
      </dgm:prSet>
      <dgm:spPr/>
    </dgm:pt>
    <dgm:pt modelId="{32D2A57E-57C4-4F16-BCEF-BC8043789599}" type="pres">
      <dgm:prSet presAssocID="{57370633-D8C0-4378-8908-A7448631B801}" presName="circ1" presStyleLbl="vennNode1" presStyleIdx="0" presStyleCnt="3" custScaleX="105087" custScaleY="102018" custLinFactNeighborX="-9017" custLinFactNeighborY="26983"/>
      <dgm:spPr/>
    </dgm:pt>
    <dgm:pt modelId="{BBE789F9-3A3D-4DE8-8576-589D9CAB7474}" type="pres">
      <dgm:prSet presAssocID="{57370633-D8C0-4378-8908-A7448631B801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96C53D0E-7C3E-4119-9EDA-9EEE5963DBD7}" type="pres">
      <dgm:prSet presAssocID="{A94CC6B6-0902-4F08-BDA3-FFA46E655C21}" presName="circ2" presStyleLbl="vennNode1" presStyleIdx="1" presStyleCnt="3" custScaleX="102228" custScaleY="105913" custLinFactNeighborX="-20903" custLinFactNeighborY="-467"/>
      <dgm:spPr/>
    </dgm:pt>
    <dgm:pt modelId="{45DFB111-F9EE-4122-AAB4-3081AFC19CFB}" type="pres">
      <dgm:prSet presAssocID="{A94CC6B6-0902-4F08-BDA3-FFA46E655C21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7757287D-0BF7-4AF9-B608-63B1B4A33653}" type="pres">
      <dgm:prSet presAssocID="{23C6CA5F-52DB-4FE0-ACC5-0DC1BF0811F3}" presName="circ3" presStyleLbl="vennNode1" presStyleIdx="2" presStyleCnt="3" custScaleX="102963" custScaleY="107686" custLinFactNeighborX="-2411" custLinFactNeighborY="419"/>
      <dgm:spPr/>
    </dgm:pt>
    <dgm:pt modelId="{DCBFECD6-35ED-4D63-A664-C86ED1ADC42F}" type="pres">
      <dgm:prSet presAssocID="{23C6CA5F-52DB-4FE0-ACC5-0DC1BF0811F3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8F70BA0B-6A54-42CA-AEFE-F6BE67CEB85F}" type="presOf" srcId="{A94CC6B6-0902-4F08-BDA3-FFA46E655C21}" destId="{96C53D0E-7C3E-4119-9EDA-9EEE5963DBD7}" srcOrd="0" destOrd="0" presId="urn:microsoft.com/office/officeart/2005/8/layout/venn1"/>
    <dgm:cxn modelId="{CA2E6C2C-40BD-423D-8F21-296B07A8048E}" srcId="{4E1A14E2-19FD-4E95-B481-8E02EB3805E9}" destId="{23C6CA5F-52DB-4FE0-ACC5-0DC1BF0811F3}" srcOrd="2" destOrd="0" parTransId="{0AE87402-5C21-4F40-85E5-E4A2860BF368}" sibTransId="{838F3D91-E2F8-467B-9453-1B8E0ACC7AFE}"/>
    <dgm:cxn modelId="{E730D63F-87B6-4D87-AC6D-0458A5BECF5B}" type="presOf" srcId="{57370633-D8C0-4378-8908-A7448631B801}" destId="{32D2A57E-57C4-4F16-BCEF-BC8043789599}" srcOrd="0" destOrd="0" presId="urn:microsoft.com/office/officeart/2005/8/layout/venn1"/>
    <dgm:cxn modelId="{DDB60441-EFC6-4BF7-8CBB-98BDC9A159F5}" type="presOf" srcId="{23C6CA5F-52DB-4FE0-ACC5-0DC1BF0811F3}" destId="{DCBFECD6-35ED-4D63-A664-C86ED1ADC42F}" srcOrd="1" destOrd="0" presId="urn:microsoft.com/office/officeart/2005/8/layout/venn1"/>
    <dgm:cxn modelId="{40006164-D635-42BF-B016-E52050C5C2D9}" type="presOf" srcId="{57370633-D8C0-4378-8908-A7448631B801}" destId="{BBE789F9-3A3D-4DE8-8576-589D9CAB7474}" srcOrd="1" destOrd="0" presId="urn:microsoft.com/office/officeart/2005/8/layout/venn1"/>
    <dgm:cxn modelId="{1E9F614E-1FCF-485F-8B24-42E227A9ED9D}" type="presOf" srcId="{4E1A14E2-19FD-4E95-B481-8E02EB3805E9}" destId="{9FBCDCD4-7E21-4714-8908-19321FF1462C}" srcOrd="0" destOrd="0" presId="urn:microsoft.com/office/officeart/2005/8/layout/venn1"/>
    <dgm:cxn modelId="{E1A89A98-BAFA-4AEC-AB27-057107757FBA}" type="presOf" srcId="{23C6CA5F-52DB-4FE0-ACC5-0DC1BF0811F3}" destId="{7757287D-0BF7-4AF9-B608-63B1B4A33653}" srcOrd="0" destOrd="0" presId="urn:microsoft.com/office/officeart/2005/8/layout/venn1"/>
    <dgm:cxn modelId="{CF4AF3C1-3F03-4957-8F5C-2AD9F093CDD0}" srcId="{4E1A14E2-19FD-4E95-B481-8E02EB3805E9}" destId="{57370633-D8C0-4378-8908-A7448631B801}" srcOrd="0" destOrd="0" parTransId="{1E3C3A12-CFBA-42D1-B4D8-09E9718C85BA}" sibTransId="{3F083593-D0DD-4F12-BD32-6C0793E6AE1E}"/>
    <dgm:cxn modelId="{F50AB5D1-84AC-468E-966C-46654A711B9A}" type="presOf" srcId="{A94CC6B6-0902-4F08-BDA3-FFA46E655C21}" destId="{45DFB111-F9EE-4122-AAB4-3081AFC19CFB}" srcOrd="1" destOrd="0" presId="urn:microsoft.com/office/officeart/2005/8/layout/venn1"/>
    <dgm:cxn modelId="{ABC3F7E9-A992-4404-A8B4-1AED97D2AB9B}" srcId="{4E1A14E2-19FD-4E95-B481-8E02EB3805E9}" destId="{A94CC6B6-0902-4F08-BDA3-FFA46E655C21}" srcOrd="1" destOrd="0" parTransId="{2F0296AA-8FEB-4911-B042-86714345132F}" sibTransId="{54553347-1A16-446E-94E6-9C874E9EEE69}"/>
    <dgm:cxn modelId="{CA7135CF-D615-4AA3-A1E5-5B1A7876C284}" type="presParOf" srcId="{9FBCDCD4-7E21-4714-8908-19321FF1462C}" destId="{32D2A57E-57C4-4F16-BCEF-BC8043789599}" srcOrd="0" destOrd="0" presId="urn:microsoft.com/office/officeart/2005/8/layout/venn1"/>
    <dgm:cxn modelId="{9AE89100-C9E7-490A-AD66-144D37D0F285}" type="presParOf" srcId="{9FBCDCD4-7E21-4714-8908-19321FF1462C}" destId="{BBE789F9-3A3D-4DE8-8576-589D9CAB7474}" srcOrd="1" destOrd="0" presId="urn:microsoft.com/office/officeart/2005/8/layout/venn1"/>
    <dgm:cxn modelId="{A39FE4BB-1100-45D0-A9E9-5997F06AE0ED}" type="presParOf" srcId="{9FBCDCD4-7E21-4714-8908-19321FF1462C}" destId="{96C53D0E-7C3E-4119-9EDA-9EEE5963DBD7}" srcOrd="2" destOrd="0" presId="urn:microsoft.com/office/officeart/2005/8/layout/venn1"/>
    <dgm:cxn modelId="{E0776FEC-FEAA-4E86-9EA1-59D9F3F2DD75}" type="presParOf" srcId="{9FBCDCD4-7E21-4714-8908-19321FF1462C}" destId="{45DFB111-F9EE-4122-AAB4-3081AFC19CFB}" srcOrd="3" destOrd="0" presId="urn:microsoft.com/office/officeart/2005/8/layout/venn1"/>
    <dgm:cxn modelId="{1110B48D-5748-41E6-9C24-C6A738AB73EF}" type="presParOf" srcId="{9FBCDCD4-7E21-4714-8908-19321FF1462C}" destId="{7757287D-0BF7-4AF9-B608-63B1B4A33653}" srcOrd="4" destOrd="0" presId="urn:microsoft.com/office/officeart/2005/8/layout/venn1"/>
    <dgm:cxn modelId="{446C0CFB-9124-4E7D-BD4A-83C491CEB35F}" type="presParOf" srcId="{9FBCDCD4-7E21-4714-8908-19321FF1462C}" destId="{DCBFECD6-35ED-4D63-A664-C86ED1ADC42F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2D2A57E-57C4-4F16-BCEF-BC8043789599}">
      <dsp:nvSpPr>
        <dsp:cNvPr id="0" name=""/>
        <dsp:cNvSpPr/>
      </dsp:nvSpPr>
      <dsp:spPr>
        <a:xfrm>
          <a:off x="1605949" y="521664"/>
          <a:ext cx="2057788" cy="1997692"/>
        </a:xfrm>
        <a:prstGeom prst="ellipse">
          <a:avLst/>
        </a:prstGeom>
        <a:solidFill>
          <a:srgbClr val="E325E8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0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880321" y="871260"/>
        <a:ext cx="1509044" cy="898961"/>
      </dsp:txXfrm>
    </dsp:sp>
    <dsp:sp modelId="{96C53D0E-7C3E-4119-9EDA-9EEE5963DBD7}">
      <dsp:nvSpPr>
        <dsp:cNvPr id="0" name=""/>
        <dsp:cNvSpPr/>
      </dsp:nvSpPr>
      <dsp:spPr>
        <a:xfrm>
          <a:off x="2107768" y="1169869"/>
          <a:ext cx="2001804" cy="2073963"/>
        </a:xfrm>
        <a:prstGeom prst="ellipse">
          <a:avLst/>
        </a:prstGeom>
        <a:solidFill>
          <a:schemeClr val="accent4">
            <a:alpha val="50000"/>
            <a:hueOff val="5197846"/>
            <a:satOff val="-23984"/>
            <a:lumOff val="88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719986" y="1705643"/>
        <a:ext cx="1201082" cy="1140679"/>
      </dsp:txXfrm>
    </dsp:sp>
    <dsp:sp modelId="{7757287D-0BF7-4AF9-B608-63B1B4A33653}">
      <dsp:nvSpPr>
        <dsp:cNvPr id="0" name=""/>
        <dsp:cNvSpPr/>
      </dsp:nvSpPr>
      <dsp:spPr>
        <a:xfrm>
          <a:off x="1049527" y="1161655"/>
          <a:ext cx="2016196" cy="2108681"/>
        </a:xfrm>
        <a:prstGeom prst="ellipse">
          <a:avLst/>
        </a:prstGeom>
        <a:solidFill>
          <a:srgbClr val="FFFF0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400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54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239385" y="1706398"/>
        <a:ext cx="1209718" cy="115977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543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64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46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9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568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043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617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022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9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609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2BD6E-8C27-4CBE-B6B1-3ACE3EE8B947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48E26-BC59-41A2-8908-6D403000D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044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42127" y="858203"/>
            <a:ext cx="6543968" cy="4203387"/>
            <a:chOff x="1555146" y="271427"/>
            <a:chExt cx="6543968" cy="4203387"/>
          </a:xfrm>
        </p:grpSpPr>
        <p:grpSp>
          <p:nvGrpSpPr>
            <p:cNvPr id="3" name="그룹 32"/>
            <p:cNvGrpSpPr/>
            <p:nvPr/>
          </p:nvGrpSpPr>
          <p:grpSpPr>
            <a:xfrm>
              <a:off x="2367604" y="271427"/>
              <a:ext cx="5731510" cy="1043940"/>
              <a:chOff x="0" y="0"/>
              <a:chExt cx="5731510" cy="1043999"/>
            </a:xfrm>
          </p:grpSpPr>
          <p:pic>
            <p:nvPicPr>
              <p:cNvPr id="20" name="그림 2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481"/>
              <a:stretch/>
            </p:blipFill>
            <p:spPr bwMode="auto">
              <a:xfrm>
                <a:off x="0" y="60384"/>
                <a:ext cx="5731510" cy="983615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21" name="직선 화살표 연결선 29"/>
              <p:cNvCxnSpPr/>
              <p:nvPr/>
            </p:nvCxnSpPr>
            <p:spPr>
              <a:xfrm>
                <a:off x="1992702" y="733245"/>
                <a:ext cx="44658" cy="10196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직선 화살표 연결선 30"/>
              <p:cNvCxnSpPr/>
              <p:nvPr/>
            </p:nvCxnSpPr>
            <p:spPr>
              <a:xfrm>
                <a:off x="2234242" y="0"/>
                <a:ext cx="38735" cy="1016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Group 3"/>
            <p:cNvGrpSpPr/>
            <p:nvPr/>
          </p:nvGrpSpPr>
          <p:grpSpPr>
            <a:xfrm>
              <a:off x="2367604" y="1592348"/>
              <a:ext cx="5731510" cy="1043954"/>
              <a:chOff x="2367604" y="1592348"/>
              <a:chExt cx="5731510" cy="1043954"/>
            </a:xfrm>
          </p:grpSpPr>
          <p:pic>
            <p:nvPicPr>
              <p:cNvPr id="17" name="그림 24">
                <a:extLst>
                  <a:ext uri="{FF2B5EF4-FFF2-40B4-BE49-F238E27FC236}">
                    <a16:creationId xmlns:a16="http://schemas.microsoft.com/office/drawing/2014/main" id="{00000000-0008-0000-0200-000018000000}"/>
                  </a:ext>
                </a:extLst>
              </p:cNvPr>
              <p:cNvPicPr/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439"/>
              <a:stretch/>
            </p:blipFill>
            <p:spPr bwMode="auto">
              <a:xfrm>
                <a:off x="2367604" y="1647607"/>
                <a:ext cx="5731510" cy="98869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8" name="직선 화살표 연결선 22">
                <a:extLst>
                  <a:ext uri="{FF2B5EF4-FFF2-40B4-BE49-F238E27FC236}">
                    <a16:creationId xmlns:a16="http://schemas.microsoft.com/office/drawing/2014/main" id="{4FB3DC68-6BA7-4F50-8C87-F83B95FE3866}"/>
                  </a:ext>
                </a:extLst>
              </p:cNvPr>
              <p:cNvCxnSpPr/>
              <p:nvPr/>
            </p:nvCxnSpPr>
            <p:spPr>
              <a:xfrm>
                <a:off x="4382739" y="2335212"/>
                <a:ext cx="44450" cy="1016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직선 화살표 연결선 23">
                <a:extLst>
                  <a:ext uri="{FF2B5EF4-FFF2-40B4-BE49-F238E27FC236}">
                    <a16:creationId xmlns:a16="http://schemas.microsoft.com/office/drawing/2014/main" id="{BE12C132-DC88-4E73-A95D-24688D20711F}"/>
                  </a:ext>
                </a:extLst>
              </p:cNvPr>
              <p:cNvCxnSpPr/>
              <p:nvPr/>
            </p:nvCxnSpPr>
            <p:spPr>
              <a:xfrm>
                <a:off x="4770089" y="1592348"/>
                <a:ext cx="38735" cy="1016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/>
            <p:cNvGrpSpPr/>
            <p:nvPr/>
          </p:nvGrpSpPr>
          <p:grpSpPr>
            <a:xfrm>
              <a:off x="2367604" y="2530210"/>
              <a:ext cx="5731510" cy="988695"/>
              <a:chOff x="2367604" y="2958822"/>
              <a:chExt cx="5731510" cy="988695"/>
            </a:xfrm>
          </p:grpSpPr>
          <p:pic>
            <p:nvPicPr>
              <p:cNvPr id="14" name="그림 18">
                <a:extLst>
                  <a:ext uri="{FF2B5EF4-FFF2-40B4-BE49-F238E27FC236}">
                    <a16:creationId xmlns:a16="http://schemas.microsoft.com/office/drawing/2014/main" id="{00000000-0008-0000-0200-00001A000000}"/>
                  </a:ext>
                </a:extLst>
              </p:cNvPr>
              <p:cNvPicPr/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439"/>
              <a:stretch/>
            </p:blipFill>
            <p:spPr bwMode="auto">
              <a:xfrm>
                <a:off x="2367604" y="2958822"/>
                <a:ext cx="5731510" cy="98869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" name="직선 화살표 연결선 22">
                <a:extLst>
                  <a:ext uri="{FF2B5EF4-FFF2-40B4-BE49-F238E27FC236}">
                    <a16:creationId xmlns:a16="http://schemas.microsoft.com/office/drawing/2014/main" id="{4FB3DC68-6BA7-4F50-8C87-F83B95FE3866}"/>
                  </a:ext>
                </a:extLst>
              </p:cNvPr>
              <p:cNvCxnSpPr/>
              <p:nvPr/>
            </p:nvCxnSpPr>
            <p:spPr>
              <a:xfrm>
                <a:off x="4344004" y="3441287"/>
                <a:ext cx="44450" cy="1016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직선 화살표 연결선 23">
                <a:extLst>
                  <a:ext uri="{FF2B5EF4-FFF2-40B4-BE49-F238E27FC236}">
                    <a16:creationId xmlns:a16="http://schemas.microsoft.com/office/drawing/2014/main" id="{BE12C132-DC88-4E73-A95D-24688D20711F}"/>
                  </a:ext>
                </a:extLst>
              </p:cNvPr>
              <p:cNvCxnSpPr/>
              <p:nvPr/>
            </p:nvCxnSpPr>
            <p:spPr>
              <a:xfrm>
                <a:off x="4770088" y="3100346"/>
                <a:ext cx="38735" cy="1016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/>
            <p:cNvGrpSpPr/>
            <p:nvPr/>
          </p:nvGrpSpPr>
          <p:grpSpPr>
            <a:xfrm>
              <a:off x="2367604" y="3486119"/>
              <a:ext cx="5731510" cy="988695"/>
              <a:chOff x="2367604" y="4356302"/>
              <a:chExt cx="5731510" cy="988695"/>
            </a:xfrm>
          </p:grpSpPr>
          <p:pic>
            <p:nvPicPr>
              <p:cNvPr id="11" name="그림 15">
                <a:extLst>
                  <a:ext uri="{FF2B5EF4-FFF2-40B4-BE49-F238E27FC236}">
                    <a16:creationId xmlns:a16="http://schemas.microsoft.com/office/drawing/2014/main" id="{00000000-0008-0000-0200-00001B000000}"/>
                  </a:ext>
                </a:extLst>
              </p:cNvPr>
              <p:cNvPicPr/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439"/>
              <a:stretch/>
            </p:blipFill>
            <p:spPr bwMode="auto">
              <a:xfrm>
                <a:off x="2367604" y="4356302"/>
                <a:ext cx="5731510" cy="98869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2" name="직선 화살표 연결선 22">
                <a:extLst>
                  <a:ext uri="{FF2B5EF4-FFF2-40B4-BE49-F238E27FC236}">
                    <a16:creationId xmlns:a16="http://schemas.microsoft.com/office/drawing/2014/main" id="{4FB3DC68-6BA7-4F50-8C87-F83B95FE3866}"/>
                  </a:ext>
                </a:extLst>
              </p:cNvPr>
              <p:cNvCxnSpPr/>
              <p:nvPr/>
            </p:nvCxnSpPr>
            <p:spPr>
              <a:xfrm>
                <a:off x="4356146" y="4943051"/>
                <a:ext cx="44450" cy="1016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직선 화살표 연결선 23">
                <a:extLst>
                  <a:ext uri="{FF2B5EF4-FFF2-40B4-BE49-F238E27FC236}">
                    <a16:creationId xmlns:a16="http://schemas.microsoft.com/office/drawing/2014/main" id="{BE12C132-DC88-4E73-A95D-24688D20711F}"/>
                  </a:ext>
                </a:extLst>
              </p:cNvPr>
              <p:cNvCxnSpPr/>
              <p:nvPr/>
            </p:nvCxnSpPr>
            <p:spPr>
              <a:xfrm>
                <a:off x="4772913" y="4466887"/>
                <a:ext cx="38735" cy="1016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/>
            <p:cNvSpPr txBox="1"/>
            <p:nvPr/>
          </p:nvSpPr>
          <p:spPr>
            <a:xfrm>
              <a:off x="1570636" y="660790"/>
              <a:ext cx="736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andard 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570635" y="2055478"/>
              <a:ext cx="8002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B koreana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570635" y="2878090"/>
              <a:ext cx="8996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B thunbergii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55146" y="3846456"/>
              <a:ext cx="9653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B amurensis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sp>
        <p:nvSpPr>
          <p:cNvPr id="23" name="Rectangle 22"/>
          <p:cNvSpPr/>
          <p:nvPr/>
        </p:nvSpPr>
        <p:spPr>
          <a:xfrm>
            <a:off x="227430" y="5832011"/>
            <a:ext cx="118179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HPLC Standard 100mg/L berberine (red) and berbamine (green) RT(retention time), followed by berbamine and berberine RT for each sample.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red arrow indicates berberine and the green arrow indicates berbamine. </a:t>
            </a:r>
          </a:p>
        </p:txBody>
      </p:sp>
    </p:spTree>
    <p:extLst>
      <p:ext uri="{BB962C8B-B14F-4D97-AF65-F5344CB8AC3E}">
        <p14:creationId xmlns:p14="http://schemas.microsoft.com/office/powerpoint/2010/main" val="4134569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08870" y="5049641"/>
            <a:ext cx="10683005" cy="553998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 Heat map and volcano plot of all differentially expressed genes (red upregulated and blue down regulated). The expression levels of unigenes were significantly different between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thunbergii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amurens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P&lt;0.05). A total of 4495 and 3016 genes were identified as DEGs in 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thunbergi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amurens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P&lt;0.05, absolute FC&gt;1; blue and red). </a:t>
            </a: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93872" y="1658780"/>
            <a:ext cx="2341906" cy="23419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08870" y="1514102"/>
            <a:ext cx="2486584" cy="24865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1342" y="1441263"/>
            <a:ext cx="2559423" cy="2559423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417061" y="4389003"/>
            <a:ext cx="247411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B koreana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B thunbergii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8418863" y="4386664"/>
            <a:ext cx="16738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 korean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en-US" sz="1000" i="1">
                <a:latin typeface="Arial" panose="020B0604020202020204" pitchFamily="34" charset="0"/>
                <a:cs typeface="Arial" panose="020B0604020202020204" pitchFamily="34" charset="0"/>
              </a:rPr>
              <a:t>B amurensis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내용 개체 틀 6">
            <a:extLst>
              <a:ext uri="{FF2B5EF4-FFF2-40B4-BE49-F238E27FC236}">
                <a16:creationId xmlns:a16="http://schemas.microsoft.com/office/drawing/2014/main" id="{959A2AA7-7A81-45CD-8D64-79962F67978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7902" y="1658780"/>
            <a:ext cx="2341906" cy="2341906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-28581" y="805831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A)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561951" y="805831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B) </a:t>
            </a:r>
          </a:p>
        </p:txBody>
      </p:sp>
    </p:spTree>
    <p:extLst>
      <p:ext uri="{BB962C8B-B14F-4D97-AF65-F5344CB8AC3E}">
        <p14:creationId xmlns:p14="http://schemas.microsoft.com/office/powerpoint/2010/main" val="1659741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11329" y="1181402"/>
            <a:ext cx="5615629" cy="3263627"/>
            <a:chOff x="518200" y="1410002"/>
            <a:chExt cx="5615629" cy="3263627"/>
          </a:xfrm>
        </p:grpSpPr>
        <p:grpSp>
          <p:nvGrpSpPr>
            <p:cNvPr id="3" name="Group 2"/>
            <p:cNvGrpSpPr/>
            <p:nvPr/>
          </p:nvGrpSpPr>
          <p:grpSpPr>
            <a:xfrm>
              <a:off x="518200" y="1410002"/>
              <a:ext cx="5615629" cy="3263627"/>
              <a:chOff x="232913" y="2971160"/>
              <a:chExt cx="5113546" cy="2920681"/>
            </a:xfrm>
          </p:grpSpPr>
          <p:graphicFrame>
            <p:nvGraphicFramePr>
              <p:cNvPr id="10" name="Diagram 9"/>
              <p:cNvGraphicFramePr/>
              <p:nvPr>
                <p:extLst>
                  <p:ext uri="{D42A27DB-BD31-4B8C-83A1-F6EECF244321}">
                    <p14:modId xmlns:p14="http://schemas.microsoft.com/office/powerpoint/2010/main" val="515155685"/>
                  </p:ext>
                </p:extLst>
              </p:nvPr>
            </p:nvGraphicFramePr>
            <p:xfrm>
              <a:off x="232913" y="2971160"/>
              <a:ext cx="5113546" cy="2920681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grpSp>
            <p:nvGrpSpPr>
              <p:cNvPr id="11" name="Group 10"/>
              <p:cNvGrpSpPr/>
              <p:nvPr/>
            </p:nvGrpSpPr>
            <p:grpSpPr>
              <a:xfrm>
                <a:off x="464930" y="3174530"/>
                <a:ext cx="4212914" cy="2333416"/>
                <a:chOff x="464930" y="3174530"/>
                <a:chExt cx="4212914" cy="2333416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2339339" y="4683971"/>
                  <a:ext cx="511181" cy="2272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404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2265593" y="3174530"/>
                  <a:ext cx="788521" cy="234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. koreana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3788606" y="5273826"/>
                  <a:ext cx="889238" cy="234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. thunbergii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464930" y="5219687"/>
                  <a:ext cx="916972" cy="234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. amurensis</a:t>
                  </a:r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2245185" y="2787900"/>
              <a:ext cx="4106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498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57725" y="2787900"/>
              <a:ext cx="4106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815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34561" y="4019012"/>
              <a:ext cx="4106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26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84956" y="3749067"/>
              <a:ext cx="4860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046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80728" y="2037953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34320" y="3752020"/>
              <a:ext cx="4106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566</a:t>
              </a:r>
            </a:p>
          </p:txBody>
        </p:sp>
      </p:grpSp>
      <p:sp>
        <p:nvSpPr>
          <p:cNvPr id="16" name="Rectangle 15"/>
          <p:cNvSpPr/>
          <p:nvPr/>
        </p:nvSpPr>
        <p:spPr>
          <a:xfrm>
            <a:off x="896385" y="5720089"/>
            <a:ext cx="1071501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3 Venn diagram showing total number of differentially expressing genes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. koreana, B. amurensi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. thunbergii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46326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6742874"/>
              </p:ext>
            </p:extLst>
          </p:nvPr>
        </p:nvGraphicFramePr>
        <p:xfrm>
          <a:off x="200794" y="677528"/>
          <a:ext cx="5872835" cy="4181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0487" y="5580307"/>
            <a:ext cx="12011025" cy="120032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Supplementary Figure S4 Functional categories of (A) upregulated DEG genes and (B) down regulated genes in the Gene Ontology </a:t>
            </a:r>
          </a:p>
          <a:p>
            <a:r>
              <a:rPr lang="en-US" dirty="0">
                <a:solidFill>
                  <a:schemeClr val="tx1"/>
                </a:solidFill>
              </a:rPr>
              <a:t>Blue bars represents unigenes in </a:t>
            </a:r>
            <a:r>
              <a:rPr lang="en-US" i="1" dirty="0">
                <a:solidFill>
                  <a:schemeClr val="tx1"/>
                </a:solidFill>
              </a:rPr>
              <a:t>B. thunbergii </a:t>
            </a:r>
            <a:r>
              <a:rPr lang="en-US" dirty="0">
                <a:solidFill>
                  <a:schemeClr val="tx1"/>
                </a:solidFill>
              </a:rPr>
              <a:t>and orange bars represents unigenes in </a:t>
            </a:r>
            <a:r>
              <a:rPr lang="en-US" i="1" dirty="0">
                <a:solidFill>
                  <a:schemeClr val="tx1"/>
                </a:solidFill>
              </a:rPr>
              <a:t>B. amurensis</a:t>
            </a:r>
            <a:r>
              <a:rPr lang="en-US" dirty="0">
                <a:solidFill>
                  <a:schemeClr val="tx1"/>
                </a:solidFill>
              </a:rPr>
              <a:t>. DEG genes were classified into biological process, cellular component and molecular function. 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657276" y="904316"/>
            <a:ext cx="5073882" cy="177575"/>
            <a:chOff x="707793" y="941163"/>
            <a:chExt cx="5073882" cy="177575"/>
          </a:xfrm>
        </p:grpSpPr>
        <p:sp>
          <p:nvSpPr>
            <p:cNvPr id="5" name="Rectangle 4"/>
            <p:cNvSpPr/>
            <p:nvPr/>
          </p:nvSpPr>
          <p:spPr>
            <a:xfrm>
              <a:off x="707793" y="941164"/>
              <a:ext cx="1107629" cy="177574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800" dirty="0"/>
                <a:t>Biological process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815423" y="941163"/>
              <a:ext cx="2254644" cy="17757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Cellular component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070067" y="941165"/>
              <a:ext cx="1711608" cy="177573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Molecular Function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5857875" y="677528"/>
            <a:ext cx="6476062" cy="4181475"/>
            <a:chOff x="5496862" y="719587"/>
            <a:chExt cx="6476062" cy="4181475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99611402"/>
                </p:ext>
              </p:extLst>
            </p:nvPr>
          </p:nvGraphicFramePr>
          <p:xfrm>
            <a:off x="5496862" y="719587"/>
            <a:ext cx="6476062" cy="41814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Rectangle 12"/>
            <p:cNvSpPr/>
            <p:nvPr/>
          </p:nvSpPr>
          <p:spPr>
            <a:xfrm>
              <a:off x="5962864" y="941163"/>
              <a:ext cx="1809536" cy="182787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iological process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7772400" y="941162"/>
              <a:ext cx="2019300" cy="182788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Cellular component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9791700" y="941162"/>
              <a:ext cx="2007045" cy="182788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Molecular Function</a:t>
              </a:r>
            </a:p>
          </p:txBody>
        </p:sp>
      </p:grpSp>
      <p:sp>
        <p:nvSpPr>
          <p:cNvPr id="16" name="Rectangle 15"/>
          <p:cNvSpPr/>
          <p:nvPr/>
        </p:nvSpPr>
        <p:spPr>
          <a:xfrm>
            <a:off x="-28581" y="805831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A) </a:t>
            </a:r>
          </a:p>
        </p:txBody>
      </p:sp>
      <p:sp>
        <p:nvSpPr>
          <p:cNvPr id="17" name="Rectangle 16"/>
          <p:cNvSpPr/>
          <p:nvPr/>
        </p:nvSpPr>
        <p:spPr>
          <a:xfrm>
            <a:off x="5561951" y="805831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B) </a:t>
            </a:r>
          </a:p>
        </p:txBody>
      </p:sp>
    </p:spTree>
    <p:extLst>
      <p:ext uri="{BB962C8B-B14F-4D97-AF65-F5344CB8AC3E}">
        <p14:creationId xmlns:p14="http://schemas.microsoft.com/office/powerpoint/2010/main" val="18910258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71270" y="6102905"/>
            <a:ext cx="11220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S5 Upregulated DEG unigenes in pathways analysis based on the KEGG database in (A) </a:t>
            </a:r>
            <a:r>
              <a:rPr lang="en-US" i="1" dirty="0"/>
              <a:t>B amurensis </a:t>
            </a:r>
            <a:r>
              <a:rPr lang="en-US" dirty="0"/>
              <a:t>vs </a:t>
            </a:r>
            <a:r>
              <a:rPr lang="en-US" i="1" dirty="0"/>
              <a:t>B koreana </a:t>
            </a:r>
            <a:r>
              <a:rPr lang="en-US" dirty="0"/>
              <a:t>and</a:t>
            </a:r>
            <a:r>
              <a:rPr lang="en-US" i="1" dirty="0"/>
              <a:t>  </a:t>
            </a:r>
            <a:r>
              <a:rPr lang="en-US" dirty="0"/>
              <a:t>(B) </a:t>
            </a:r>
            <a:r>
              <a:rPr lang="en-US" i="1" dirty="0"/>
              <a:t>B thunbergii </a:t>
            </a:r>
            <a:r>
              <a:rPr lang="en-US" dirty="0"/>
              <a:t>vs </a:t>
            </a:r>
            <a:r>
              <a:rPr lang="en-US" i="1" dirty="0"/>
              <a:t>B koreana </a:t>
            </a:r>
          </a:p>
        </p:txBody>
      </p:sp>
      <p:pic>
        <p:nvPicPr>
          <p:cNvPr id="4" name="Picture 2" descr="C:\Users\Administrator\Desktop\K4_3\k4_3-berberis10\K4_3_L-vs-Berberis10.DESeq.pval-0.05-log2FC-abs1.txt.set1.go.kegg_Pashway_U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747" y="1614582"/>
            <a:ext cx="5913280" cy="35479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6434313" y="1245250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7" name="Rectangle 6"/>
          <p:cNvSpPr/>
          <p:nvPr/>
        </p:nvSpPr>
        <p:spPr>
          <a:xfrm>
            <a:off x="112490" y="1245250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A)</a:t>
            </a:r>
          </a:p>
        </p:txBody>
      </p:sp>
      <p:pic>
        <p:nvPicPr>
          <p:cNvPr id="9" name="Picture 2" descr="C:\Users\Administrator\Desktop\K4_3\K4_3_L-japan\K4_3_L-vs-japan_17_1.DESeq.pval-0.05-log2FC-abs1.txt.set1.go.kegg_Pashway_UP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2284" y="1643740"/>
            <a:ext cx="5816086" cy="34896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193907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Administrator\Desktop\K4_3\k4_3-berberis10\K4_3_L-vs-Berberis10.DESeq.pval-0.05-log2FC-abs1.txt.set1.go.kegg_Pashway_DOWN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90" y="1738407"/>
            <a:ext cx="5913280" cy="35479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6434313" y="1245250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4" name="Rectangle 3"/>
          <p:cNvSpPr/>
          <p:nvPr/>
        </p:nvSpPr>
        <p:spPr>
          <a:xfrm>
            <a:off x="112490" y="1245250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(A)</a:t>
            </a:r>
          </a:p>
        </p:txBody>
      </p:sp>
      <p:pic>
        <p:nvPicPr>
          <p:cNvPr id="6" name="Picture 2" descr="C:\Users\Administrator\Desktop\K4_3\K4_3_L-japan\K4_3_L-vs-japan_17_1.DESeq.pval-0.05-log2FC-abs1.txt.set1.go.kegg_Pashway_DOWN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5770" y="1738407"/>
            <a:ext cx="5960521" cy="35763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341880" y="6045755"/>
            <a:ext cx="1155042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S6 Downregulated DEG unigenes in pathways analysis based on the KEGG database in (A) </a:t>
            </a:r>
            <a:r>
              <a:rPr lang="en-US" i="1" dirty="0"/>
              <a:t>B amurensis </a:t>
            </a:r>
            <a:r>
              <a:rPr lang="en-US" dirty="0"/>
              <a:t>vs </a:t>
            </a:r>
            <a:r>
              <a:rPr lang="en-US" i="1" dirty="0"/>
              <a:t>B koreana </a:t>
            </a:r>
            <a:r>
              <a:rPr lang="en-US" dirty="0"/>
              <a:t>and</a:t>
            </a:r>
            <a:r>
              <a:rPr lang="en-US" i="1" dirty="0"/>
              <a:t>  </a:t>
            </a:r>
            <a:r>
              <a:rPr lang="en-US" dirty="0"/>
              <a:t>(B) </a:t>
            </a:r>
            <a:r>
              <a:rPr lang="en-US" i="1" dirty="0"/>
              <a:t>B thunbergii </a:t>
            </a:r>
            <a:r>
              <a:rPr lang="en-US" dirty="0"/>
              <a:t>vs </a:t>
            </a:r>
            <a:r>
              <a:rPr lang="en-US" i="1" dirty="0"/>
              <a:t>B koreana </a:t>
            </a:r>
          </a:p>
        </p:txBody>
      </p:sp>
    </p:spTree>
    <p:extLst>
      <p:ext uri="{BB962C8B-B14F-4D97-AF65-F5344CB8AC3E}">
        <p14:creationId xmlns:p14="http://schemas.microsoft.com/office/powerpoint/2010/main" val="3398940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50</TotalTime>
  <Words>334</Words>
  <Application>Microsoft Office PowerPoint</Application>
  <PresentationFormat>Widescreen</PresentationFormat>
  <Paragraphs>3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a roy</dc:creator>
  <cp:lastModifiedBy>MDPI</cp:lastModifiedBy>
  <cp:revision>92</cp:revision>
  <dcterms:created xsi:type="dcterms:W3CDTF">2021-10-07T06:42:03Z</dcterms:created>
  <dcterms:modified xsi:type="dcterms:W3CDTF">2022-10-11T12:19:47Z</dcterms:modified>
</cp:coreProperties>
</file>